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1" r:id="rId2"/>
    <p:sldId id="262" r:id="rId3"/>
    <p:sldId id="263" r:id="rId4"/>
  </p:sldIdLst>
  <p:sldSz cx="6858000" cy="109728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30" d="100"/>
          <a:sy n="130" d="100"/>
        </p:scale>
        <p:origin x="522" y="-57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795781"/>
            <a:ext cx="5829300" cy="382016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763261"/>
            <a:ext cx="5143500" cy="2649219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79E66-0590-46FF-A527-B87816E6183E}" type="datetimeFigureOut">
              <a:rPr lang="en-US" smtClean="0"/>
              <a:t>02-Dec-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A54CCE-92A0-4EF5-B42D-A49E557C88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25509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79E66-0590-46FF-A527-B87816E6183E}" type="datetimeFigureOut">
              <a:rPr lang="en-US" smtClean="0"/>
              <a:t>02-Dec-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A54CCE-92A0-4EF5-B42D-A49E557C88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28831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84200"/>
            <a:ext cx="1478756" cy="9298941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84200"/>
            <a:ext cx="4350544" cy="9298941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79E66-0590-46FF-A527-B87816E6183E}" type="datetimeFigureOut">
              <a:rPr lang="en-US" smtClean="0"/>
              <a:t>02-Dec-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A54CCE-92A0-4EF5-B42D-A49E557C88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70269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79E66-0590-46FF-A527-B87816E6183E}" type="datetimeFigureOut">
              <a:rPr lang="en-US" smtClean="0"/>
              <a:t>02-Dec-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A54CCE-92A0-4EF5-B42D-A49E557C88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29152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735583"/>
            <a:ext cx="5915025" cy="456437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7343143"/>
            <a:ext cx="5915025" cy="24002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79E66-0590-46FF-A527-B87816E6183E}" type="datetimeFigureOut">
              <a:rPr lang="en-US" smtClean="0"/>
              <a:t>02-Dec-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A54CCE-92A0-4EF5-B42D-A49E557C88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77465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921000"/>
            <a:ext cx="2914650" cy="6962141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921000"/>
            <a:ext cx="2914650" cy="6962141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79E66-0590-46FF-A527-B87816E6183E}" type="datetimeFigureOut">
              <a:rPr lang="en-US" smtClean="0"/>
              <a:t>02-Dec-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A54CCE-92A0-4EF5-B42D-A49E557C88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23003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84202"/>
            <a:ext cx="5915025" cy="2120901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689861"/>
            <a:ext cx="2901255" cy="131825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008120"/>
            <a:ext cx="2901255" cy="5895341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689861"/>
            <a:ext cx="2915543" cy="131825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008120"/>
            <a:ext cx="2915543" cy="5895341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79E66-0590-46FF-A527-B87816E6183E}" type="datetimeFigureOut">
              <a:rPr lang="en-US" smtClean="0"/>
              <a:t>02-Dec-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A54CCE-92A0-4EF5-B42D-A49E557C88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76946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79E66-0590-46FF-A527-B87816E6183E}" type="datetimeFigureOut">
              <a:rPr lang="en-US" smtClean="0"/>
              <a:t>02-Dec-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A54CCE-92A0-4EF5-B42D-A49E557C88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765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79E66-0590-46FF-A527-B87816E6183E}" type="datetimeFigureOut">
              <a:rPr lang="en-US" smtClean="0"/>
              <a:t>02-Dec-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A54CCE-92A0-4EF5-B42D-A49E557C88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10144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731520"/>
            <a:ext cx="2211884" cy="256032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579882"/>
            <a:ext cx="3471863" cy="7797800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291840"/>
            <a:ext cx="2211884" cy="6098541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79E66-0590-46FF-A527-B87816E6183E}" type="datetimeFigureOut">
              <a:rPr lang="en-US" smtClean="0"/>
              <a:t>02-Dec-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A54CCE-92A0-4EF5-B42D-A49E557C88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5941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731520"/>
            <a:ext cx="2211884" cy="256032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579882"/>
            <a:ext cx="3471863" cy="7797800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291840"/>
            <a:ext cx="2211884" cy="6098541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79E66-0590-46FF-A527-B87816E6183E}" type="datetimeFigureOut">
              <a:rPr lang="en-US" smtClean="0"/>
              <a:t>02-Dec-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A54CCE-92A0-4EF5-B42D-A49E557C88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97330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84202"/>
            <a:ext cx="5915025" cy="212090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921000"/>
            <a:ext cx="5915025" cy="696214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0170162"/>
            <a:ext cx="1543050" cy="5842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079E66-0590-46FF-A527-B87816E6183E}" type="datetimeFigureOut">
              <a:rPr lang="en-US" smtClean="0"/>
              <a:t>02-Dec-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0170162"/>
            <a:ext cx="2314575" cy="5842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0170162"/>
            <a:ext cx="1543050" cy="5842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A54CCE-92A0-4EF5-B42D-A49E557C88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57806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 10"/>
          <p:cNvGrpSpPr/>
          <p:nvPr/>
        </p:nvGrpSpPr>
        <p:grpSpPr>
          <a:xfrm>
            <a:off x="131176" y="706395"/>
            <a:ext cx="6597352" cy="9593658"/>
            <a:chOff x="190810" y="706395"/>
            <a:chExt cx="6597352" cy="9593658"/>
          </a:xfrm>
        </p:grpSpPr>
        <p:grpSp>
          <p:nvGrpSpPr>
            <p:cNvPr id="10" name="Group 9"/>
            <p:cNvGrpSpPr/>
            <p:nvPr/>
          </p:nvGrpSpPr>
          <p:grpSpPr>
            <a:xfrm>
              <a:off x="499379" y="706395"/>
              <a:ext cx="5682971" cy="8422438"/>
              <a:chOff x="499379" y="706395"/>
              <a:chExt cx="5682971" cy="8422438"/>
            </a:xfrm>
          </p:grpSpPr>
          <p:pic>
            <p:nvPicPr>
              <p:cNvPr id="2" name="Picture 1"/>
              <p:cNvPicPr preferRelativeResize="0">
                <a:picLocks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771" r="17489"/>
              <a:stretch/>
            </p:blipFill>
            <p:spPr>
              <a:xfrm>
                <a:off x="499379" y="1356433"/>
                <a:ext cx="1618488" cy="7772400"/>
              </a:xfrm>
              <a:prstGeom prst="rect">
                <a:avLst/>
              </a:prstGeom>
            </p:spPr>
          </p:pic>
          <p:sp>
            <p:nvSpPr>
              <p:cNvPr id="3" name="TextBox 2"/>
              <p:cNvSpPr txBox="1"/>
              <p:nvPr/>
            </p:nvSpPr>
            <p:spPr>
              <a:xfrm>
                <a:off x="952113" y="786241"/>
                <a:ext cx="63350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G1</a:t>
                </a:r>
                <a:endParaRPr lang="en-US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5" name="Picture 4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974" r="3048"/>
              <a:stretch/>
            </p:blipFill>
            <p:spPr>
              <a:xfrm>
                <a:off x="2883926" y="1356433"/>
                <a:ext cx="1310511" cy="7772400"/>
              </a:xfrm>
              <a:prstGeom prst="rect">
                <a:avLst/>
              </a:prstGeom>
            </p:spPr>
          </p:pic>
          <p:sp>
            <p:nvSpPr>
              <p:cNvPr id="6" name="TextBox 5"/>
              <p:cNvSpPr txBox="1"/>
              <p:nvPr/>
            </p:nvSpPr>
            <p:spPr>
              <a:xfrm>
                <a:off x="3061568" y="722436"/>
                <a:ext cx="63350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G2</a:t>
                </a:r>
                <a:endParaRPr lang="en-US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>
                <a:off x="5146341" y="706395"/>
                <a:ext cx="63350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G3</a:t>
                </a:r>
                <a:endParaRPr lang="en-US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8" name="Picture 7"/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264" r="78"/>
              <a:stretch/>
            </p:blipFill>
            <p:spPr>
              <a:xfrm>
                <a:off x="4822088" y="1321383"/>
                <a:ext cx="1360262" cy="7772400"/>
              </a:xfrm>
              <a:prstGeom prst="rect">
                <a:avLst/>
              </a:prstGeom>
            </p:spPr>
          </p:pic>
        </p:grpSp>
        <p:sp>
          <p:nvSpPr>
            <p:cNvPr id="9" name="Rectangle 8"/>
            <p:cNvSpPr/>
            <p:nvPr/>
          </p:nvSpPr>
          <p:spPr>
            <a:xfrm>
              <a:off x="190810" y="9453667"/>
              <a:ext cx="6597352" cy="84638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US" sz="1200" b="1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Supplementary Figure</a:t>
              </a:r>
              <a:r>
                <a:rPr lang="en-US" sz="1200" b="1" dirty="0" smtClean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(1</a:t>
              </a:r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.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Collinearity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alysis of population specific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b-composite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inkage maps with consensus linkage map. For each linkage groups- at left is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‘SB-MK’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ap, central- consensus map and at right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‘D-MK’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ap.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e common SNP markers among the three maps are connected by </a:t>
              </a:r>
              <a:r>
                <a:rPr lang="en-US" sz="12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live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colored lines.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8862385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 10"/>
          <p:cNvGrpSpPr/>
          <p:nvPr/>
        </p:nvGrpSpPr>
        <p:grpSpPr>
          <a:xfrm>
            <a:off x="141113" y="796236"/>
            <a:ext cx="6597352" cy="9554617"/>
            <a:chOff x="121235" y="745436"/>
            <a:chExt cx="6597352" cy="9554617"/>
          </a:xfrm>
        </p:grpSpPr>
        <p:sp>
          <p:nvSpPr>
            <p:cNvPr id="2" name="Rectangle 1"/>
            <p:cNvSpPr/>
            <p:nvPr/>
          </p:nvSpPr>
          <p:spPr>
            <a:xfrm>
              <a:off x="121235" y="9453667"/>
              <a:ext cx="6597352" cy="84638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US" sz="1200" b="1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Supplementary Figure</a:t>
              </a:r>
              <a:r>
                <a:rPr lang="en-US" sz="1200" b="1" dirty="0" smtClean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(2</a:t>
              </a:r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.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Collinearity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alysis of population specific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b-composite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inkage maps with consensus linkage map. For each linkage groups- at left is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‘SB-MK’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ap, central- consensus map and at right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‘D-MK’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ap.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e common SNP markers among the three maps are connected by </a:t>
              </a:r>
              <a:r>
                <a:rPr lang="en-US" sz="12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live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colored lines.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0" name="Group 9"/>
            <p:cNvGrpSpPr/>
            <p:nvPr/>
          </p:nvGrpSpPr>
          <p:grpSpPr>
            <a:xfrm>
              <a:off x="432641" y="745436"/>
              <a:ext cx="6000264" cy="8529357"/>
              <a:chOff x="522092" y="745436"/>
              <a:chExt cx="6000264" cy="8529357"/>
            </a:xfrm>
          </p:grpSpPr>
          <p:pic>
            <p:nvPicPr>
              <p:cNvPr id="4" name="Picture 3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4348" r="28160" b="2807"/>
              <a:stretch/>
            </p:blipFill>
            <p:spPr>
              <a:xfrm>
                <a:off x="522092" y="1500809"/>
                <a:ext cx="1247157" cy="7772400"/>
              </a:xfrm>
              <a:prstGeom prst="rect">
                <a:avLst/>
              </a:prstGeom>
            </p:spPr>
          </p:pic>
          <p:sp>
            <p:nvSpPr>
              <p:cNvPr id="5" name="TextBox 4"/>
              <p:cNvSpPr txBox="1"/>
              <p:nvPr/>
            </p:nvSpPr>
            <p:spPr>
              <a:xfrm>
                <a:off x="834890" y="745436"/>
                <a:ext cx="63350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G4</a:t>
                </a:r>
                <a:endParaRPr lang="en-US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" name="TextBox 5"/>
              <p:cNvSpPr txBox="1"/>
              <p:nvPr/>
            </p:nvSpPr>
            <p:spPr>
              <a:xfrm>
                <a:off x="2926663" y="748751"/>
                <a:ext cx="63350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G5</a:t>
                </a:r>
                <a:endParaRPr lang="en-US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8" name="Picture 7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5706" r="6365" b="4620"/>
              <a:stretch/>
            </p:blipFill>
            <p:spPr>
              <a:xfrm>
                <a:off x="4682350" y="1502393"/>
                <a:ext cx="1840006" cy="7772400"/>
              </a:xfrm>
              <a:prstGeom prst="rect">
                <a:avLst/>
              </a:prstGeom>
            </p:spPr>
          </p:pic>
          <p:sp>
            <p:nvSpPr>
              <p:cNvPr id="9" name="TextBox 8"/>
              <p:cNvSpPr txBox="1"/>
              <p:nvPr/>
            </p:nvSpPr>
            <p:spPr>
              <a:xfrm>
                <a:off x="5244548" y="752066"/>
                <a:ext cx="63350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G6</a:t>
                </a:r>
                <a:endParaRPr lang="en-US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743" r="5325" b="3827"/>
          <a:stretch/>
        </p:blipFill>
        <p:spPr>
          <a:xfrm>
            <a:off x="2272889" y="1551609"/>
            <a:ext cx="2061667" cy="7772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7851839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 9"/>
          <p:cNvGrpSpPr/>
          <p:nvPr/>
        </p:nvGrpSpPr>
        <p:grpSpPr>
          <a:xfrm>
            <a:off x="138310" y="745436"/>
            <a:ext cx="6625906" cy="9539228"/>
            <a:chOff x="232094" y="745436"/>
            <a:chExt cx="6597352" cy="9539228"/>
          </a:xfrm>
        </p:grpSpPr>
        <p:sp>
          <p:nvSpPr>
            <p:cNvPr id="2" name="Rectangle 1"/>
            <p:cNvSpPr/>
            <p:nvPr/>
          </p:nvSpPr>
          <p:spPr>
            <a:xfrm>
              <a:off x="232094" y="9453667"/>
              <a:ext cx="6597352" cy="83099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US" sz="1200" b="1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Supplementary </a:t>
              </a:r>
              <a:r>
                <a:rPr lang="en-US" sz="1200" b="1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Figure</a:t>
              </a:r>
              <a:r>
                <a:rPr lang="en-US" sz="1200" b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sz="1200" b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(3</a:t>
              </a:r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.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Collinearity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alysis of population specific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b-composite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inkage maps with consensus linkage map. For each linkage groups- at left is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‘SB-MK’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ap, central- consensus map and at right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‘D-MK’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ap.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e common SNP markers among the three maps are connected by </a:t>
              </a:r>
              <a:r>
                <a:rPr lang="en-US" sz="12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live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colored lines.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9" name="Group 8"/>
            <p:cNvGrpSpPr/>
            <p:nvPr/>
          </p:nvGrpSpPr>
          <p:grpSpPr>
            <a:xfrm>
              <a:off x="549282" y="745436"/>
              <a:ext cx="5728939" cy="8433728"/>
              <a:chOff x="549282" y="745436"/>
              <a:chExt cx="5728939" cy="8433728"/>
            </a:xfrm>
          </p:grpSpPr>
          <p:pic>
            <p:nvPicPr>
              <p:cNvPr id="3" name="Picture 2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068" r="23782"/>
              <a:stretch/>
            </p:blipFill>
            <p:spPr>
              <a:xfrm>
                <a:off x="549282" y="1406764"/>
                <a:ext cx="1305435" cy="7772400"/>
              </a:xfrm>
              <a:prstGeom prst="rect">
                <a:avLst/>
              </a:prstGeom>
            </p:spPr>
          </p:pic>
          <p:sp>
            <p:nvSpPr>
              <p:cNvPr id="4" name="TextBox 3"/>
              <p:cNvSpPr txBox="1"/>
              <p:nvPr/>
            </p:nvSpPr>
            <p:spPr>
              <a:xfrm>
                <a:off x="929439" y="745436"/>
                <a:ext cx="63350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G7</a:t>
                </a:r>
                <a:endParaRPr lang="en-US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" name="TextBox 4"/>
              <p:cNvSpPr txBox="1"/>
              <p:nvPr/>
            </p:nvSpPr>
            <p:spPr>
              <a:xfrm>
                <a:off x="2791881" y="748751"/>
                <a:ext cx="63350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G8</a:t>
                </a:r>
                <a:endParaRPr lang="en-US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" name="TextBox 5"/>
              <p:cNvSpPr txBox="1"/>
              <p:nvPr/>
            </p:nvSpPr>
            <p:spPr>
              <a:xfrm>
                <a:off x="5034299" y="752066"/>
                <a:ext cx="63350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G9</a:t>
                </a:r>
                <a:endParaRPr lang="en-US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7" name="Picture 6"/>
              <p:cNvPicPr>
                <a:picLocks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3247" r="15452" b="11966"/>
              <a:stretch/>
            </p:blipFill>
            <p:spPr>
              <a:xfrm>
                <a:off x="2409626" y="1406764"/>
                <a:ext cx="1618488" cy="7772400"/>
              </a:xfrm>
              <a:prstGeom prst="rect">
                <a:avLst/>
              </a:prstGeom>
            </p:spPr>
          </p:pic>
          <p:pic>
            <p:nvPicPr>
              <p:cNvPr id="8" name="Picture 7"/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-1" t="3633" r="21148" b="2778"/>
              <a:stretch/>
            </p:blipFill>
            <p:spPr>
              <a:xfrm>
                <a:off x="4583023" y="1383319"/>
                <a:ext cx="1695198" cy="7772400"/>
              </a:xfrm>
              <a:prstGeom prst="rect">
                <a:avLst/>
              </a:prstGeom>
            </p:spPr>
          </p:pic>
        </p:grpSp>
      </p:grpSp>
    </p:spTree>
    <p:extLst>
      <p:ext uri="{BB962C8B-B14F-4D97-AF65-F5344CB8AC3E}">
        <p14:creationId xmlns:p14="http://schemas.microsoft.com/office/powerpoint/2010/main" val="16031739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5</TotalTime>
  <Words>174</Words>
  <Application>Microsoft Office PowerPoint</Application>
  <PresentationFormat>Custom</PresentationFormat>
  <Paragraphs>12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account</dc:creator>
  <cp:lastModifiedBy>Microsoft account</cp:lastModifiedBy>
  <cp:revision>31</cp:revision>
  <dcterms:created xsi:type="dcterms:W3CDTF">2022-10-14T07:40:35Z</dcterms:created>
  <dcterms:modified xsi:type="dcterms:W3CDTF">2022-12-02T17:06:31Z</dcterms:modified>
</cp:coreProperties>
</file>